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6858000" cy="9144000"/>
  <p:notesSz cx="7005638" cy="92916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5600" cy="9291600"/>
          </a:xfrm>
          <a:prstGeom prst="rect">
            <a:avLst/>
          </a:prstGeom>
          <a:solidFill>
            <a:srgbClr val="ffffff"/>
          </a:solidFill>
          <a:ln w="9360">
            <a:noFill/>
          </a:ln>
        </p:spPr>
        <p:txBody>
          <a:bodyPr lIns="90000" rIns="90000" tIns="45000" bIns="45000" anchor="ctr" anchorCtr="1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0" y="0"/>
            <a:ext cx="7005600" cy="9291600"/>
          </a:xfrm>
          <a:custGeom>
            <a:avLst/>
            <a:gdLst>
              <a:gd name="textAreaLeft" fmla="*/ 360 w 7005600"/>
              <a:gd name="textAreaRight" fmla="*/ 7005240 w 7005600"/>
              <a:gd name="textAreaTop" fmla="*/ 360 h 9291600"/>
              <a:gd name="textAreaBottom" fmla="*/ 9291240 h 9291600"/>
            </a:gdLst>
            <a:ahLst/>
            <a:rect l="textAreaLeft" t="textAreaTop" r="textAreaRight" b="textAreaBottom"/>
            <a:pathLst>
              <a:path w="21600" h="28648">
                <a:moveTo>
                  <a:pt x="4" y="0"/>
                </a:moveTo>
                <a:arcTo wR="4" hR="4" stAng="16200000" swAng="-5400000"/>
                <a:lnTo>
                  <a:pt x="0" y="28644"/>
                </a:lnTo>
                <a:arcTo wR="4" hR="4" stAng="10800000" swAng="-5400000"/>
                <a:lnTo>
                  <a:pt x="21596" y="28648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0" y="0"/>
            <a:ext cx="303516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1"/>
          <p:cNvSpPr>
            <a:spLocks noGrp="1"/>
          </p:cNvSpPr>
          <p:nvPr>
            <p:ph type="dt" idx="2"/>
          </p:nvPr>
        </p:nvSpPr>
        <p:spPr>
          <a:xfrm>
            <a:off x="3966840" y="0"/>
            <a:ext cx="3033720" cy="46368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GB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sldImg"/>
          </p:nvPr>
        </p:nvSpPr>
        <p:spPr>
          <a:xfrm>
            <a:off x="2195640" y="696960"/>
            <a:ext cx="2611440" cy="3481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3"/>
          <p:cNvSpPr>
            <a:spLocks noGrp="1"/>
          </p:cNvSpPr>
          <p:nvPr>
            <p:ph type="body"/>
          </p:nvPr>
        </p:nvSpPr>
        <p:spPr>
          <a:xfrm>
            <a:off x="700200" y="4413240"/>
            <a:ext cx="5602320" cy="417816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0" y="8823240"/>
            <a:ext cx="303516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4"/>
          <p:cNvSpPr>
            <a:spLocks noGrp="1"/>
          </p:cNvSpPr>
          <p:nvPr>
            <p:ph type="sldNum" idx="3"/>
          </p:nvPr>
        </p:nvSpPr>
        <p:spPr>
          <a:xfrm>
            <a:off x="3966840" y="8823240"/>
            <a:ext cx="3033720" cy="46368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GB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3230D0C4-3319-4E5D-A1C9-6C9DAA2DFC24}" type="slidenum">
              <a:rPr b="0" lang="en-GB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"/>
          <p:cNvSpPr/>
          <p:nvPr/>
        </p:nvSpPr>
        <p:spPr>
          <a:xfrm>
            <a:off x="2195640" y="696960"/>
            <a:ext cx="2612880" cy="3483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1"/>
          <p:cNvSpPr>
            <a:spLocks noGrp="1"/>
          </p:cNvSpPr>
          <p:nvPr>
            <p:ph type="body"/>
          </p:nvPr>
        </p:nvSpPr>
        <p:spPr>
          <a:xfrm>
            <a:off x="700200" y="4412880"/>
            <a:ext cx="5603760" cy="4181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"/>
          <p:cNvSpPr/>
          <p:nvPr/>
        </p:nvSpPr>
        <p:spPr>
          <a:xfrm>
            <a:off x="2195640" y="696960"/>
            <a:ext cx="2612880" cy="3483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1"/>
          <p:cNvSpPr>
            <a:spLocks noGrp="1"/>
          </p:cNvSpPr>
          <p:nvPr>
            <p:ph type="body"/>
          </p:nvPr>
        </p:nvSpPr>
        <p:spPr>
          <a:xfrm>
            <a:off x="700200" y="4412880"/>
            <a:ext cx="5603760" cy="4181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6A55FD7-AD02-4982-87E8-175405C0E5E8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86F4092-C45E-47AD-8278-1687913A27C1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08AB216-BEE4-445D-BDA9-0EFAB1A168C8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B816D48-CF10-4498-96B3-C40C753923D9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F77D5818-52E9-4675-8524-9F3DEFB08CDA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3A26AC8-68BC-4A54-8E5D-43B1FC605556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84B067A-219F-485B-88B0-17785C610D5F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FCEF7C5-3D0E-424F-AFCB-8AB3AE7FDAB4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6480"/>
            <a:ext cx="6170400" cy="705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0DD972A-A69E-4812-8D4F-56DD378657E9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7D461DF-2D1C-4933-B97B-50AC4BDCB236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ABE617D-5FFE-4BE3-A681-6590720093BD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215C265-270D-474B-B51A-4FB81EF1F0D9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1280" indent="-34128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1240" indent="-28404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"/>
          <p:cNvSpPr/>
          <p:nvPr/>
        </p:nvSpPr>
        <p:spPr>
          <a:xfrm>
            <a:off x="34308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>
          <a:xfrm>
            <a:off x="4915080" y="8326080"/>
            <a:ext cx="1598400" cy="63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B55919F8-1F3E-4C18-8C17-01788C9EA3AC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380880" y="533520"/>
            <a:ext cx="6216840" cy="396864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4114800" y="90360"/>
            <a:ext cx="2666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52280" y="30492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" descr=""/>
          <p:cNvPicPr/>
          <p:nvPr/>
        </p:nvPicPr>
        <p:blipFill>
          <a:blip r:embed="rId2"/>
          <a:stretch/>
        </p:blipFill>
        <p:spPr>
          <a:xfrm>
            <a:off x="304920" y="4952880"/>
            <a:ext cx="5914800" cy="3776760"/>
          </a:xfrm>
          <a:prstGeom prst="rect">
            <a:avLst/>
          </a:prstGeom>
          <a:ln w="0">
            <a:noFill/>
          </a:ln>
        </p:spPr>
      </p:pic>
      <p:sp>
        <p:nvSpPr>
          <p:cNvPr id="53" name=""/>
          <p:cNvSpPr/>
          <p:nvPr/>
        </p:nvSpPr>
        <p:spPr>
          <a:xfrm>
            <a:off x="152280" y="464832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V="1">
            <a:off x="257040" y="836640"/>
            <a:ext cx="347760" cy="3387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miR Expression (fold change vs RNU6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flipV="1">
            <a:off x="228600" y="5257800"/>
            <a:ext cx="347760" cy="3387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miR Expression (fold change vs RNU6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"/>
          <p:cNvSpPr/>
          <p:nvPr/>
        </p:nvSpPr>
        <p:spPr>
          <a:xfrm>
            <a:off x="4114800" y="90360"/>
            <a:ext cx="2666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52280" y="30492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76320" y="4572000"/>
            <a:ext cx="533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" descr=""/>
          <p:cNvPicPr/>
          <p:nvPr/>
        </p:nvPicPr>
        <p:blipFill>
          <a:blip r:embed="rId1"/>
          <a:stretch/>
        </p:blipFill>
        <p:spPr>
          <a:xfrm>
            <a:off x="304920" y="609480"/>
            <a:ext cx="6216480" cy="3969000"/>
          </a:xfrm>
          <a:prstGeom prst="rect">
            <a:avLst/>
          </a:prstGeom>
          <a:ln w="0">
            <a:noFill/>
          </a:ln>
        </p:spPr>
      </p:pic>
      <p:pic>
        <p:nvPicPr>
          <p:cNvPr id="60" name="" descr=""/>
          <p:cNvPicPr/>
          <p:nvPr/>
        </p:nvPicPr>
        <p:blipFill>
          <a:blip r:embed="rId2"/>
          <a:stretch/>
        </p:blipFill>
        <p:spPr>
          <a:xfrm>
            <a:off x="304920" y="4952880"/>
            <a:ext cx="6161040" cy="3932280"/>
          </a:xfrm>
          <a:prstGeom prst="rect">
            <a:avLst/>
          </a:prstGeom>
          <a:ln w="0">
            <a:noFill/>
          </a:ln>
        </p:spPr>
      </p:pic>
      <p:sp>
        <p:nvSpPr>
          <p:cNvPr id="61" name=""/>
          <p:cNvSpPr/>
          <p:nvPr/>
        </p:nvSpPr>
        <p:spPr>
          <a:xfrm flipV="1">
            <a:off x="181080" y="801720"/>
            <a:ext cx="347760" cy="3387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miR Expression (fold change vs RNU6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V="1">
            <a:off x="228600" y="5222880"/>
            <a:ext cx="347760" cy="3387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miR Expression (fold change vs RNU6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kondadasula sri vidya</dc:creator>
  <dc:description/>
  <dc:language>en-US</dc:language>
  <cp:lastModifiedBy>grig09</cp:lastModifiedBy>
  <cp:revision>0</cp:revision>
  <dc:subject/>
  <dc:title>Slide 1</dc:title>
</cp:coreProperties>
</file>